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FF"/>
    <a:srgbClr val="FFCCFF"/>
    <a:srgbClr val="FFFF99"/>
    <a:srgbClr val="B6D2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1339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504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6733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1864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3861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1970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3529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5390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456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739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873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3043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804347-0BAC-4858-82A8-6D72002672E5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E3DDA6-4BED-4908-8B6C-DAD477D80E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154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>
            <a:extLst>
              <a:ext uri="{FF2B5EF4-FFF2-40B4-BE49-F238E27FC236}">
                <a16:creationId xmlns:a16="http://schemas.microsoft.com/office/drawing/2014/main" id="{80C88EC9-5CA9-4957-BC83-71343A58605B}"/>
              </a:ext>
            </a:extLst>
          </p:cNvPr>
          <p:cNvGrpSpPr>
            <a:grpSpLocks noChangeAspect="1"/>
          </p:cNvGrpSpPr>
          <p:nvPr/>
        </p:nvGrpSpPr>
        <p:grpSpPr>
          <a:xfrm>
            <a:off x="1644439" y="371521"/>
            <a:ext cx="5855121" cy="4241171"/>
            <a:chOff x="387681" y="602354"/>
            <a:chExt cx="8261548" cy="5984272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9D4BFA96-5027-4FBD-97AA-A67F0D371E1B}"/>
                </a:ext>
              </a:extLst>
            </p:cNvPr>
            <p:cNvSpPr txBox="1"/>
            <p:nvPr/>
          </p:nvSpPr>
          <p:spPr>
            <a:xfrm>
              <a:off x="412928" y="602354"/>
              <a:ext cx="64026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61914A7-36C5-45CC-83B9-3B8043DADEB6}"/>
                </a:ext>
              </a:extLst>
            </p:cNvPr>
            <p:cNvSpPr txBox="1"/>
            <p:nvPr/>
          </p:nvSpPr>
          <p:spPr>
            <a:xfrm>
              <a:off x="7985720" y="651656"/>
              <a:ext cx="64026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6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dirty="0"/>
                <a:t>B</a:t>
              </a:r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26AE9C8C-8937-499B-ACA7-0C291D710F7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6105" y="879051"/>
              <a:ext cx="3533138" cy="2691915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517D6999-4CE8-40D0-B08F-BAE60166D2F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75831" y="879051"/>
              <a:ext cx="3533138" cy="2691914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5E26FA3-A7F4-4334-A646-7C5E2B85D306}"/>
                </a:ext>
              </a:extLst>
            </p:cNvPr>
            <p:cNvSpPr txBox="1"/>
            <p:nvPr/>
          </p:nvSpPr>
          <p:spPr>
            <a:xfrm>
              <a:off x="387681" y="3628980"/>
              <a:ext cx="64026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5128253-278E-40C7-A518-875C60331B78}"/>
                </a:ext>
              </a:extLst>
            </p:cNvPr>
            <p:cNvSpPr txBox="1"/>
            <p:nvPr/>
          </p:nvSpPr>
          <p:spPr>
            <a:xfrm>
              <a:off x="8008966" y="3628980"/>
              <a:ext cx="64026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6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dirty="0"/>
                <a:t>D</a:t>
              </a:r>
            </a:p>
          </p:txBody>
        </p: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D238A978-395E-4E24-B031-0ED7DA94B7E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6105" y="3894710"/>
              <a:ext cx="3533139" cy="2691916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327557E8-D6AE-412B-B0E8-F1788DB6D45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75830" y="3894710"/>
              <a:ext cx="3533138" cy="2691914"/>
            </a:xfrm>
            <a:prstGeom prst="rect">
              <a:avLst/>
            </a:prstGeom>
          </p:spPr>
        </p:pic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9B666C56-9C7B-4453-9E76-7C5AB823BB66}"/>
                </a:ext>
              </a:extLst>
            </p:cNvPr>
            <p:cNvCxnSpPr/>
            <p:nvPr/>
          </p:nvCxnSpPr>
          <p:spPr>
            <a:xfrm>
              <a:off x="878615" y="3474513"/>
              <a:ext cx="188007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74CBFB8A-A6C8-EA3E-0E1F-E1698ED1CDB8}"/>
              </a:ext>
            </a:extLst>
          </p:cNvPr>
          <p:cNvSpPr txBox="1"/>
          <p:nvPr/>
        </p:nvSpPr>
        <p:spPr>
          <a:xfrm>
            <a:off x="1112164" y="4801018"/>
            <a:ext cx="6637299" cy="15618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indent="0" algn="just" eaLnBrk="0" fontAlgn="base" hangingPunct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</a:t>
            </a:r>
            <a:r>
              <a:rPr lang="en-US" sz="1200" b="1" kern="12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3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teps of the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eri-neuronal ring fluorescence analysis using an </a:t>
            </a:r>
            <a:r>
              <a:rPr lang="en-US" sz="1200" i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n-house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ImageJ plugin. 1) Establishing the inner limit of the ring (B) starting from IHC images (A: representative NF200 (+) neurons staining used to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nalyze the Iba1 (+) macrophages around and on top of them). 2)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Establishing the outer limit of the ring at a constant value added to the inner limit of the ring (C), calculated to cover the ring of Iba1(+) macrophages around the neuron. 3) Measuring of the mean fluorescence on the ring enlarged area to analyze the Iba1 (+) macrophages around and on top of DRG neurons (D)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cale bars = 20 µm.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51586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84</TotalTime>
  <Words>130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oleta Ristoiu</dc:creator>
  <cp:lastModifiedBy>MDPI</cp:lastModifiedBy>
  <cp:revision>54</cp:revision>
  <cp:lastPrinted>2019-06-22T08:34:50Z</cp:lastPrinted>
  <dcterms:created xsi:type="dcterms:W3CDTF">2019-05-16T10:28:49Z</dcterms:created>
  <dcterms:modified xsi:type="dcterms:W3CDTF">2023-10-31T07:30:32Z</dcterms:modified>
</cp:coreProperties>
</file>